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3"/>
    <p:restoredTop sz="94659"/>
  </p:normalViewPr>
  <p:slideViewPr>
    <p:cSldViewPr snapToGrid="0" snapToObjects="1">
      <p:cViewPr varScale="1">
        <p:scale>
          <a:sx n="146" d="100"/>
          <a:sy n="146" d="100"/>
        </p:scale>
        <p:origin x="9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C893AF-C8C3-D74B-8C3D-7DB69A17B659}" type="datetimeFigureOut">
              <a:rPr lang="en-US" smtClean="0"/>
              <a:t>5/3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E8A14B-4CEC-C245-83EF-ADEA1E6E9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7949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870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920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378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068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3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974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736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78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25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99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920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8C607-42ED-DC4D-8DAF-3AA1A65BA0EA}" type="datetimeFigureOut">
              <a:rPr lang="en-US" smtClean="0"/>
              <a:t>5/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1FB0A-F92A-9A42-BA42-0A1E960FB0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231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442" y="80920"/>
            <a:ext cx="7948908" cy="687823"/>
          </a:xfrm>
        </p:spPr>
        <p:txBody>
          <a:bodyPr>
            <a:normAutofit fontScale="90000"/>
          </a:bodyPr>
          <a:lstStyle/>
          <a:p>
            <a:r>
              <a:rPr lang="en-US" sz="1600" dirty="0">
                <a:latin typeface="Arial" charset="0"/>
                <a:ea typeface="Arial" charset="0"/>
                <a:cs typeface="Arial" charset="0"/>
              </a:rPr>
              <a:t>Supplementary Table </a:t>
            </a:r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2. 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The </a:t>
            </a:r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R and P </a:t>
            </a:r>
            <a:r>
              <a:rPr lang="en-US" sz="1600" dirty="0">
                <a:latin typeface="Arial" charset="0"/>
                <a:ea typeface="Arial" charset="0"/>
                <a:cs typeface="Arial" charset="0"/>
              </a:rPr>
              <a:t>values of Spearman’s analysis among the CD14+MDSC from different compartments </a:t>
            </a:r>
            <a:r>
              <a:rPr lang="en-US" sz="1600" dirty="0"/>
              <a:t/>
            </a:r>
            <a:br>
              <a:rPr lang="en-US" sz="1600" dirty="0"/>
            </a:br>
            <a:endParaRPr lang="en-US" sz="16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1737745"/>
              </p:ext>
            </p:extLst>
          </p:nvPr>
        </p:nvGraphicFramePr>
        <p:xfrm>
          <a:off x="461247" y="566441"/>
          <a:ext cx="8054103" cy="284685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87703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</a:tblGrid>
              <a:tr h="3317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R values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</a:tr>
              <a:tr h="30836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27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7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1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9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3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2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60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27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4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2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53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5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53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7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25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9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8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2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441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1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4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25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7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6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4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455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9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2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9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7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8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8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01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3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53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8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6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8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23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12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2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5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32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4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8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23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92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6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44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45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0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-0.11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9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0324230"/>
              </p:ext>
            </p:extLst>
          </p:nvPr>
        </p:nvGraphicFramePr>
        <p:xfrm>
          <a:off x="461246" y="3626191"/>
          <a:ext cx="8054103" cy="284685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87703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  <a:gridCol w="895800"/>
              </a:tblGrid>
              <a:tr h="3317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P values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</a:tr>
              <a:tr h="30836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xillary L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1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one marrow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lon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9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5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lieum LP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4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ive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4</a:t>
                      </a:r>
                    </a:p>
                  </a:txBody>
                  <a:tcPr marL="12700" marR="12700" marT="12700" marB="0" anchor="b"/>
                </a:tc>
              </a:tr>
              <a:tr h="3317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esenteric L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73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BMC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6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5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1</a:t>
                      </a:r>
                    </a:p>
                  </a:txBody>
                  <a:tcPr marL="12700" marR="12700" marT="12700" marB="0" anchor="b"/>
                </a:tc>
              </a:tr>
              <a:tr h="30216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pleen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4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8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1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3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7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2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08598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</TotalTime>
  <Words>214</Words>
  <Application>Microsoft Macintosh PowerPoint</Application>
  <PresentationFormat>On-screen Show (4:3)</PresentationFormat>
  <Paragraphs>1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Supplementary Table 2. The R and P values of Spearman’s analysis among the CD14+MDSC from different compartments  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 1. Spearman’s R values between the CM9 tetramer+CD8+T cell percentages of different compartments  </dc:title>
  <dc:creator>Microsoft Office User</dc:creator>
  <cp:lastModifiedBy>Yongjun Sui</cp:lastModifiedBy>
  <cp:revision>25</cp:revision>
  <cp:lastPrinted>2016-12-02T20:14:24Z</cp:lastPrinted>
  <dcterms:created xsi:type="dcterms:W3CDTF">2016-11-21T15:15:29Z</dcterms:created>
  <dcterms:modified xsi:type="dcterms:W3CDTF">2017-05-03T19:22:09Z</dcterms:modified>
</cp:coreProperties>
</file>